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77" autoAdjust="0"/>
    <p:restoredTop sz="94660"/>
  </p:normalViewPr>
  <p:slideViewPr>
    <p:cSldViewPr snapToGrid="0">
      <p:cViewPr varScale="1">
        <p:scale>
          <a:sx n="86" d="100"/>
          <a:sy n="86" d="100"/>
        </p:scale>
        <p:origin x="754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zutoshi Fujibayashi" userId="35483d803165e713" providerId="LiveId" clId="{57B20A9A-C5D2-4F0A-AA29-1E617B1E8BA9}"/>
    <pc:docChg chg="modSld">
      <pc:chgData name="Kazutoshi Fujibayashi" userId="35483d803165e713" providerId="LiveId" clId="{57B20A9A-C5D2-4F0A-AA29-1E617B1E8BA9}" dt="2018-04-08T05:22:44.412" v="0" actId="1037"/>
      <pc:docMkLst>
        <pc:docMk/>
      </pc:docMkLst>
      <pc:sldChg chg="modSp">
        <pc:chgData name="Kazutoshi Fujibayashi" userId="35483d803165e713" providerId="LiveId" clId="{57B20A9A-C5D2-4F0A-AA29-1E617B1E8BA9}" dt="2018-04-08T05:22:44.412" v="0" actId="1037"/>
        <pc:sldMkLst>
          <pc:docMk/>
          <pc:sldMk cId="515863111" sldId="262"/>
        </pc:sldMkLst>
        <pc:spChg chg="mod">
          <ac:chgData name="Kazutoshi Fujibayashi" userId="35483d803165e713" providerId="LiveId" clId="{57B20A9A-C5D2-4F0A-AA29-1E617B1E8BA9}" dt="2018-04-08T05:22:44.412" v="0" actId="1037"/>
          <ac:spMkLst>
            <pc:docMk/>
            <pc:sldMk cId="515863111" sldId="262"/>
            <ac:spMk id="19" creationId="{101D46F9-2A16-46E2-AE96-45B7FE727A32}"/>
          </ac:spMkLst>
        </pc:spChg>
      </pc:sldChg>
    </pc:docChg>
  </pc:docChgLst>
  <pc:docChgLst>
    <pc:chgData name="Fujibayashi Kazutoshi" userId="35483d803165e713" providerId="LiveId" clId="{57B20A9A-C5D2-4F0A-AA29-1E617B1E8BA9}"/>
    <pc:docChg chg="modSld">
      <pc:chgData name="Fujibayashi Kazutoshi" userId="35483d803165e713" providerId="LiveId" clId="{57B20A9A-C5D2-4F0A-AA29-1E617B1E8BA9}" dt="2018-04-15T01:06:22.941" v="0" actId="1038"/>
      <pc:docMkLst>
        <pc:docMk/>
      </pc:docMkLst>
      <pc:sldChg chg="modSp">
        <pc:chgData name="Fujibayashi Kazutoshi" userId="35483d803165e713" providerId="LiveId" clId="{57B20A9A-C5D2-4F0A-AA29-1E617B1E8BA9}" dt="2018-04-15T01:06:22.941" v="0" actId="1038"/>
        <pc:sldMkLst>
          <pc:docMk/>
          <pc:sldMk cId="515863111" sldId="262"/>
        </pc:sldMkLst>
        <pc:spChg chg="mod">
          <ac:chgData name="Fujibayashi Kazutoshi" userId="35483d803165e713" providerId="LiveId" clId="{57B20A9A-C5D2-4F0A-AA29-1E617B1E8BA9}" dt="2018-04-15T01:06:22.941" v="0" actId="1038"/>
          <ac:spMkLst>
            <pc:docMk/>
            <pc:sldMk cId="515863111" sldId="262"/>
            <ac:spMk id="2" creationId="{27E20A0F-4A21-47C8-84A5-60E4E24F467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ED5760-0859-4561-AB31-DFD4082E1F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DE77751-A8B0-4A7B-A395-E92919F0A4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字幕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1DB647-E8F3-45C4-8304-799565C8C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1ADE9B-7C4C-4FE2-9FC2-1B75FB12B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A2A4AC-7B54-4F0F-95B6-ED89AAF99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8602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BB4FCB-CB6B-43A7-A7AB-69CD6B32D9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11B60CD-624F-4BD4-AEC6-4606C37B94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B05BF00-A91F-416A-9BD9-E4F45E903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CE01A2-2035-41A4-A355-9ED49D8E0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ED5FD2D-89EA-44C2-B4EC-00866E16D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0549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4DDF89D-C2EF-4103-923C-C325FEE071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DF734B8-D831-4124-B918-DB9FDB9F5E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D1F6893-1A95-455D-B807-C35B3AA4A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4DFAC17-3106-4109-A961-83AEF39E1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DB9262-B76B-4A88-8228-69DBA33AB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7716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5E37DC-3106-4A53-97CA-A6BA1F5A28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4D4DA2A-FA83-4E37-B61B-115A083402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4EC916-2C5A-48AF-8233-06F7949AD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5872BA-B70B-4055-A3BA-3AE95C77F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4ADE67-2F66-4E11-9A9E-77A8DEA8B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411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9E84D8-BCAC-47FE-B4C3-3A42610815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9BA6382-8AB4-415B-BCB5-CAD480352A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B2B346-6F6C-44C9-98CE-F974DB2A8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6ED9800-05BE-496B-919F-17385A40E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CACBE73-B9C2-411F-A3D3-6AE26AF97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4177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BB608F-E050-46E8-9A57-7D5A1C1709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4D66821-48F9-4720-8182-7E78051294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FE4AEAB-9B39-40A8-A5A8-F43CA1D13B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3FB7775-6151-4823-AE6D-5C414C10D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BE152AD-AB98-4DDC-A09F-F358E5F5A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BE308C-3946-45F2-8DBF-082079CF04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529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3FFF1E-9CC0-4C99-BC52-F8B13EFB5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1848DFA-A71A-4EFB-94B3-1137C76162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3DD24E4-92BD-43FB-BD6B-113AAB6124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575DACC-68DA-4B9D-8A03-97DBEEACDD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71A9290-143C-4DF1-893A-062F47F77C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1EE1305-767A-440E-8ED3-53DA3260F1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FF4C2E3-E181-48D9-A354-F66E4AA35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E0EB3D5-0AFB-4C81-B1AB-554C78F24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356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DA2880-F669-47AE-B30B-D4DEABC1A8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FB4DFE9-7854-458B-89F0-AB93E86FA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C1F56C3-4F88-479B-8F9E-9E05E24A0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073DD89-4D88-473B-A65A-4017BEA2B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1487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9D209B8-B1B4-40A8-957C-D5A98C6D7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243A3BE-0800-4576-8640-83A0A8B3B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021DCF7-F58F-46BD-8354-CC70BB541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4785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693F03-37B2-4506-8784-3A6026399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4BCECC9-68B0-4990-81B5-A7B4D59CC9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3FA0E94-6833-4376-B586-107FF88A2E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61664F8-44C0-4223-B8CE-C97BA3CC3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51B5D56-F623-4DE9-83CA-3363CA42A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B8588EB-39D2-430E-AC02-E181DEF07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663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98A072-E1AC-49E8-AE7E-7BBAB41BB7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7FA7A10-AF6D-4979-A596-8703087322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5DF0A07-3CA5-4731-A964-F2FCB7FC48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7D90739-2345-49E7-822F-3778D3F1A5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84357BF-E4BA-4ABC-ACFF-2F2FFC22A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FF3375-D5EF-4A51-8889-10FB28AF2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487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6D4E041-09D9-474D-832F-C03838418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A0B1A4B-F944-4EAA-9851-CBAFE4A9E4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8C2340-7FBF-44F4-BB59-333556B576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83C4765-0016-4E9F-B503-257034349F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39D935D-D100-414C-995A-BD382B629D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9990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3E329D99-57FC-EB4E-8A0F-AFC0B5DA1E8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0515" y="123721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F3EC1FDC-E55A-DF45-9BC1-17882A300D5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2257" y="123721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A4030F43-2F46-5B46-9D35-3788896D1DE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8773" y="146969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2C6A07E2-4204-BA4B-A533-172DC572A28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901" y="3483486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7C5588FB-AA4B-6F4F-A609-58EDB64B74B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2257" y="3483486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4F48486B-9794-9046-A366-7F448FC8E740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030" y="146969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7E484C09-1FBC-634B-A31C-3F3213BF212A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77031" y="129685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7E20A0F-4A21-47C8-84A5-60E4E24F4678}"/>
              </a:ext>
            </a:extLst>
          </p:cNvPr>
          <p:cNvSpPr/>
          <p:nvPr/>
        </p:nvSpPr>
        <p:spPr>
          <a:xfrm>
            <a:off x="315589" y="2129924"/>
            <a:ext cx="1700642" cy="50783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o participate in this research for the first time, please input your information.</a:t>
            </a: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1B21BC37-2D51-4E77-887A-BAECA1F9EB7C}"/>
              </a:ext>
            </a:extLst>
          </p:cNvPr>
          <p:cNvSpPr/>
          <p:nvPr/>
        </p:nvSpPr>
        <p:spPr>
          <a:xfrm>
            <a:off x="2683804" y="1743719"/>
            <a:ext cx="1821589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lease let us know whether we should address you as a man or a woman.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BC704553-4527-45CA-A39C-FF39D09FB5F5}"/>
              </a:ext>
            </a:extLst>
          </p:cNvPr>
          <p:cNvSpPr/>
          <p:nvPr/>
        </p:nvSpPr>
        <p:spPr>
          <a:xfrm>
            <a:off x="2876520" y="992281"/>
            <a:ext cx="457411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an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6F77081D-6A86-4EBA-B486-E5DB3DE9305B}"/>
              </a:ext>
            </a:extLst>
          </p:cNvPr>
          <p:cNvSpPr/>
          <p:nvPr/>
        </p:nvSpPr>
        <p:spPr>
          <a:xfrm>
            <a:off x="2876520" y="1325965"/>
            <a:ext cx="62460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Woman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2BEAD4E-2E95-4884-BCDE-B18E98E9C939}"/>
              </a:ext>
            </a:extLst>
          </p:cNvPr>
          <p:cNvSpPr/>
          <p:nvPr/>
        </p:nvSpPr>
        <p:spPr>
          <a:xfrm>
            <a:off x="5229947" y="730671"/>
            <a:ext cx="128272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How old are you?</a:t>
            </a: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37C7FEA9-9B5C-40B0-A6BD-A11654FDFB0B}"/>
              </a:ext>
            </a:extLst>
          </p:cNvPr>
          <p:cNvSpPr/>
          <p:nvPr/>
        </p:nvSpPr>
        <p:spPr>
          <a:xfrm>
            <a:off x="5264582" y="1319956"/>
            <a:ext cx="91403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years old</a:t>
            </a: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D5E7AA66-C0BC-48C0-B8A0-DAB361D0DA10}"/>
              </a:ext>
            </a:extLst>
          </p:cNvPr>
          <p:cNvSpPr/>
          <p:nvPr/>
        </p:nvSpPr>
        <p:spPr>
          <a:xfrm>
            <a:off x="7391531" y="730671"/>
            <a:ext cx="1633781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Do you have any diseases?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5752D281-A0BB-4C85-A483-B886D8E07874}"/>
              </a:ext>
            </a:extLst>
          </p:cNvPr>
          <p:cNvSpPr/>
          <p:nvPr/>
        </p:nvSpPr>
        <p:spPr>
          <a:xfrm>
            <a:off x="7872405" y="936338"/>
            <a:ext cx="67197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Diabete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25988855-4345-4BEE-95F2-901EFF4CF6DA}"/>
              </a:ext>
            </a:extLst>
          </p:cNvPr>
          <p:cNvSpPr/>
          <p:nvPr/>
        </p:nvSpPr>
        <p:spPr>
          <a:xfrm>
            <a:off x="7944905" y="1248537"/>
            <a:ext cx="110799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ronchial asthm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05B2B01F-DACB-4936-81D8-78B713212863}"/>
              </a:ext>
            </a:extLst>
          </p:cNvPr>
          <p:cNvSpPr/>
          <p:nvPr/>
        </p:nvSpPr>
        <p:spPr>
          <a:xfrm>
            <a:off x="7857606" y="1560735"/>
            <a:ext cx="82586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mphysem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3D83B283-64D1-4056-BDB5-E113EAFE3035}"/>
              </a:ext>
            </a:extLst>
          </p:cNvPr>
          <p:cNvSpPr/>
          <p:nvPr/>
        </p:nvSpPr>
        <p:spPr>
          <a:xfrm>
            <a:off x="8010006" y="1801910"/>
            <a:ext cx="9284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ome oxygen 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herapy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0B335204-0CBE-4F04-8C95-4AD2D4831ECA}"/>
              </a:ext>
            </a:extLst>
          </p:cNvPr>
          <p:cNvSpPr/>
          <p:nvPr/>
        </p:nvSpPr>
        <p:spPr>
          <a:xfrm>
            <a:off x="7780664" y="2167377"/>
            <a:ext cx="582211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Dialysi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B54CD29F-708C-498C-96A3-197FEA550CDB}"/>
              </a:ext>
            </a:extLst>
          </p:cNvPr>
          <p:cNvSpPr/>
          <p:nvPr/>
        </p:nvSpPr>
        <p:spPr>
          <a:xfrm>
            <a:off x="7870918" y="2506210"/>
            <a:ext cx="97975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ngina pectori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6CEDA306-9F13-4AF9-A7FE-C6D4B4D12BA9}"/>
              </a:ext>
            </a:extLst>
          </p:cNvPr>
          <p:cNvSpPr/>
          <p:nvPr/>
        </p:nvSpPr>
        <p:spPr>
          <a:xfrm>
            <a:off x="7916782" y="2809532"/>
            <a:ext cx="124264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yocardial infarction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A0E4F5C5-9158-490B-B788-ABE1281C24B8}"/>
              </a:ext>
            </a:extLst>
          </p:cNvPr>
          <p:cNvSpPr/>
          <p:nvPr/>
        </p:nvSpPr>
        <p:spPr>
          <a:xfrm>
            <a:off x="7873871" y="3103974"/>
            <a:ext cx="110799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ronchial asthm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05595DDE-588C-431A-A5F3-4DB90EC875EE}"/>
              </a:ext>
            </a:extLst>
          </p:cNvPr>
          <p:cNvSpPr/>
          <p:nvPr/>
        </p:nvSpPr>
        <p:spPr>
          <a:xfrm>
            <a:off x="10026801" y="730671"/>
            <a:ext cx="92204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hysique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7504C93E-C29F-4FDA-A99B-519DD3FA5219}"/>
              </a:ext>
            </a:extLst>
          </p:cNvPr>
          <p:cNvSpPr/>
          <p:nvPr/>
        </p:nvSpPr>
        <p:spPr>
          <a:xfrm>
            <a:off x="9748592" y="1915585"/>
            <a:ext cx="125547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What is your weight?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85DD1003-2C64-463A-8C6A-14981CDAC488}"/>
              </a:ext>
            </a:extLst>
          </p:cNvPr>
          <p:cNvSpPr/>
          <p:nvPr/>
        </p:nvSpPr>
        <p:spPr>
          <a:xfrm>
            <a:off x="9741544" y="1698290"/>
            <a:ext cx="123623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What is your height?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434898FF-0D22-419B-9EC9-755070E120A0}"/>
              </a:ext>
            </a:extLst>
          </p:cNvPr>
          <p:cNvSpPr/>
          <p:nvPr/>
        </p:nvSpPr>
        <p:spPr>
          <a:xfrm>
            <a:off x="309670" y="4631894"/>
            <a:ext cx="16530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lease enter the zip code for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your place of residence.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図 46">
            <a:extLst>
              <a:ext uri="{FF2B5EF4-FFF2-40B4-BE49-F238E27FC236}">
                <a16:creationId xmlns:a16="http://schemas.microsoft.com/office/drawing/2014/main" id="{FF1421C0-3B42-4E52-B26D-C5F3054B1A8C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7338" y="3482307"/>
            <a:ext cx="1821589" cy="32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7393A00B-1B9C-4CD3-9FE5-BDAF0B99CBE9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26986" y="3482307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A63EE3F0-4995-4F9C-95A6-1A2B1705B183}"/>
              </a:ext>
            </a:extLst>
          </p:cNvPr>
          <p:cNvSpPr/>
          <p:nvPr/>
        </p:nvSpPr>
        <p:spPr>
          <a:xfrm>
            <a:off x="2621059" y="3749381"/>
            <a:ext cx="1864613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habiting relatives information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3CC3A521-CF7F-4635-A32D-3D09D3869A81}"/>
              </a:ext>
            </a:extLst>
          </p:cNvPr>
          <p:cNvSpPr/>
          <p:nvPr/>
        </p:nvSpPr>
        <p:spPr>
          <a:xfrm>
            <a:off x="2151386" y="4615946"/>
            <a:ext cx="3315586" cy="3693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an you provide information about cohabiting relatives?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ow many relatives live together, including you?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0936601D-6051-4B79-878E-32337D84D1BD}"/>
              </a:ext>
            </a:extLst>
          </p:cNvPr>
          <p:cNvSpPr/>
          <p:nvPr/>
        </p:nvSpPr>
        <p:spPr>
          <a:xfrm>
            <a:off x="3941745" y="5183730"/>
            <a:ext cx="761747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nly myself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吹き出し: 角を丸めた四角形 17">
            <a:extLst>
              <a:ext uri="{FF2B5EF4-FFF2-40B4-BE49-F238E27FC236}">
                <a16:creationId xmlns:a16="http://schemas.microsoft.com/office/drawing/2014/main" id="{9639A313-1780-4898-864D-89FFF3AB93DE}"/>
              </a:ext>
            </a:extLst>
          </p:cNvPr>
          <p:cNvSpPr/>
          <p:nvPr/>
        </p:nvSpPr>
        <p:spPr>
          <a:xfrm>
            <a:off x="3724250" y="5751041"/>
            <a:ext cx="1499191" cy="548750"/>
          </a:xfrm>
          <a:prstGeom prst="wedgeRoundRectCallout">
            <a:avLst>
              <a:gd name="adj1" fmla="val -48033"/>
              <a:gd name="adj2" fmla="val -93183"/>
              <a:gd name="adj3" fmla="val 16667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ticipants can choose the number of relatives from a list provided.</a:t>
            </a:r>
            <a:endParaRPr kumimoji="1" lang="ja-JP" alt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101D46F9-2A16-46E2-AE96-45B7FE727A32}"/>
              </a:ext>
            </a:extLst>
          </p:cNvPr>
          <p:cNvSpPr/>
          <p:nvPr/>
        </p:nvSpPr>
        <p:spPr>
          <a:xfrm>
            <a:off x="5689747" y="4102057"/>
            <a:ext cx="2204450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ow old are your cohabiting relatives?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61C2CB02-EF84-42DD-BDF8-C251CABA7E2A}"/>
              </a:ext>
            </a:extLst>
          </p:cNvPr>
          <p:cNvSpPr/>
          <p:nvPr/>
        </p:nvSpPr>
        <p:spPr>
          <a:xfrm>
            <a:off x="6279400" y="4384186"/>
            <a:ext cx="851515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nder 1 year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BD583B6D-2309-4820-9A2A-45D750DA664F}"/>
              </a:ext>
            </a:extLst>
          </p:cNvPr>
          <p:cNvSpPr/>
          <p:nvPr/>
        </p:nvSpPr>
        <p:spPr>
          <a:xfrm>
            <a:off x="6279400" y="4686916"/>
            <a:ext cx="1018227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1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 years 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F41FC9A4-3CBA-4566-ACFF-9F4B6F04082D}"/>
              </a:ext>
            </a:extLst>
          </p:cNvPr>
          <p:cNvSpPr/>
          <p:nvPr/>
        </p:nvSpPr>
        <p:spPr>
          <a:xfrm>
            <a:off x="8388199" y="5741277"/>
            <a:ext cx="105028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80 years or older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A33D2CD7-01FC-455B-924C-EE96D4E1E504}"/>
              </a:ext>
            </a:extLst>
          </p:cNvPr>
          <p:cNvSpPr/>
          <p:nvPr/>
        </p:nvSpPr>
        <p:spPr>
          <a:xfrm>
            <a:off x="6279400" y="4989646"/>
            <a:ext cx="1018227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6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2 yea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4B9BAA86-2FFB-4369-8FD5-E987A87D753A}"/>
              </a:ext>
            </a:extLst>
          </p:cNvPr>
          <p:cNvSpPr/>
          <p:nvPr/>
        </p:nvSpPr>
        <p:spPr>
          <a:xfrm>
            <a:off x="6279400" y="5292376"/>
            <a:ext cx="1107996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13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1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9 yea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4E0D8C0D-E8E9-4BFF-8A35-A2BF7CC5E952}"/>
              </a:ext>
            </a:extLst>
          </p:cNvPr>
          <p:cNvSpPr/>
          <p:nvPr/>
        </p:nvSpPr>
        <p:spPr>
          <a:xfrm>
            <a:off x="6279400" y="5595106"/>
            <a:ext cx="117852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20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9 years 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7522DD19-F33B-4C08-8BC5-E1C9FA382343}"/>
              </a:ext>
            </a:extLst>
          </p:cNvPr>
          <p:cNvSpPr/>
          <p:nvPr/>
        </p:nvSpPr>
        <p:spPr>
          <a:xfrm>
            <a:off x="6279400" y="5897836"/>
            <a:ext cx="114646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30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9 yea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4917C692-B3AE-4F82-B16B-DA0656CFBD45}"/>
              </a:ext>
            </a:extLst>
          </p:cNvPr>
          <p:cNvSpPr/>
          <p:nvPr/>
        </p:nvSpPr>
        <p:spPr>
          <a:xfrm>
            <a:off x="6279400" y="6200566"/>
            <a:ext cx="114646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40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9 yea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8EAB4B94-4921-4F3E-8477-2E338EB0CCA6}"/>
              </a:ext>
            </a:extLst>
          </p:cNvPr>
          <p:cNvSpPr/>
          <p:nvPr/>
        </p:nvSpPr>
        <p:spPr>
          <a:xfrm>
            <a:off x="6279400" y="6503299"/>
            <a:ext cx="111440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50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9 yea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57515E55-B9FD-4ECA-BF02-92E4760700F4}"/>
              </a:ext>
            </a:extLst>
          </p:cNvPr>
          <p:cNvSpPr/>
          <p:nvPr/>
        </p:nvSpPr>
        <p:spPr>
          <a:xfrm>
            <a:off x="8388199" y="3883904"/>
            <a:ext cx="111440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20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9 yea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20DFFD5F-2E3B-4BC7-AEFE-C10D553150F8}"/>
              </a:ext>
            </a:extLst>
          </p:cNvPr>
          <p:cNvSpPr/>
          <p:nvPr/>
        </p:nvSpPr>
        <p:spPr>
          <a:xfrm>
            <a:off x="8388199" y="4193466"/>
            <a:ext cx="1107996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30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3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9 yea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993480C6-E26C-4A0D-AE1F-2F7F5E197214}"/>
              </a:ext>
            </a:extLst>
          </p:cNvPr>
          <p:cNvSpPr/>
          <p:nvPr/>
        </p:nvSpPr>
        <p:spPr>
          <a:xfrm>
            <a:off x="8388199" y="4503028"/>
            <a:ext cx="111440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40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9 yea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34979392-A1E5-43F3-AF88-FF69F6184238}"/>
              </a:ext>
            </a:extLst>
          </p:cNvPr>
          <p:cNvSpPr/>
          <p:nvPr/>
        </p:nvSpPr>
        <p:spPr>
          <a:xfrm>
            <a:off x="8388199" y="4812590"/>
            <a:ext cx="111440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50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9 yea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2B70D16F-AB24-4989-B9B8-4446F9BC6301}"/>
              </a:ext>
            </a:extLst>
          </p:cNvPr>
          <p:cNvSpPr/>
          <p:nvPr/>
        </p:nvSpPr>
        <p:spPr>
          <a:xfrm>
            <a:off x="8388199" y="5122152"/>
            <a:ext cx="111440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60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69 yea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7DA02BB5-F43B-4497-B165-177EAC5B8918}"/>
              </a:ext>
            </a:extLst>
          </p:cNvPr>
          <p:cNvSpPr/>
          <p:nvPr/>
        </p:nvSpPr>
        <p:spPr>
          <a:xfrm>
            <a:off x="8388199" y="5431714"/>
            <a:ext cx="111440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rom 70</a:t>
            </a:r>
            <a:r>
              <a:rPr lang="en-US" altLang="ja-JP" sz="900" dirty="0">
                <a:latin typeface="Calibri"/>
                <a:cs typeface="Arial" panose="020B0604020202020204" pitchFamily="34" charset="0"/>
              </a:rPr>
              <a:t>–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9 year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5863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4</TotalTime>
  <Words>173</Words>
  <Application>Microsoft Office PowerPoint</Application>
  <PresentationFormat>ワイド画面</PresentationFormat>
  <Paragraphs>4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toshi Fujibayashi</dc:creator>
  <cp:lastModifiedBy>Fujibayashi Kazutoshi</cp:lastModifiedBy>
  <cp:revision>26</cp:revision>
  <dcterms:created xsi:type="dcterms:W3CDTF">2018-03-12T02:40:27Z</dcterms:created>
  <dcterms:modified xsi:type="dcterms:W3CDTF">2018-04-15T01:06:27Z</dcterms:modified>
</cp:coreProperties>
</file>